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1" d="100"/>
          <a:sy n="101" d="100"/>
        </p:scale>
        <p:origin x="-30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60" d="100"/>
        <a:sy n="16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2016\paper\BMC%20Genomics\Major%20revision\Figure\Table_every_data_20160104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2016\paper\BMC%20Genomics\Major%20revision\Figure\Table_every_data_20160104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9442540612656002E-2"/>
          <c:y val="0.34748849039601598"/>
          <c:w val="0.31861796679801502"/>
          <c:h val="0.52738842154735699"/>
        </c:manualLayout>
      </c:layout>
      <c:lineChart>
        <c:grouping val="standard"/>
        <c:varyColors val="0"/>
        <c:ser>
          <c:idx val="0"/>
          <c:order val="0"/>
          <c:tx>
            <c:strRef>
              <c:f>GGDEF!$A$96</c:f>
              <c:strCache>
                <c:ptCount val="1"/>
                <c:pt idx="0">
                  <c:v>EAL-GGDEF (Xoo2561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GGDEF!$B$95:$H$9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GGDEF!$B$96:$H$96</c:f>
              <c:numCache>
                <c:formatCode>General</c:formatCode>
                <c:ptCount val="7"/>
                <c:pt idx="0">
                  <c:v>1</c:v>
                </c:pt>
                <c:pt idx="1">
                  <c:v>0.580477673935618</c:v>
                </c:pt>
                <c:pt idx="2">
                  <c:v>0.44029075804776702</c:v>
                </c:pt>
                <c:pt idx="3">
                  <c:v>0.89165801315334103</c:v>
                </c:pt>
                <c:pt idx="4">
                  <c:v>2.7798546209761161</c:v>
                </c:pt>
                <c:pt idx="5">
                  <c:v>2.6611284181377641</c:v>
                </c:pt>
                <c:pt idx="6">
                  <c:v>1.9979231568016611</c:v>
                </c:pt>
              </c:numCache>
            </c:numRef>
          </c:val>
          <c:smooth val="1"/>
        </c:ser>
        <c:ser>
          <c:idx val="1"/>
          <c:order val="1"/>
          <c:tx>
            <c:strRef>
              <c:f>GGDEF!$A$97</c:f>
              <c:strCache>
                <c:ptCount val="1"/>
                <c:pt idx="0">
                  <c:v>EAL-GGDEF (Xoo2616)</c:v>
                </c:pt>
              </c:strCache>
            </c:strRef>
          </c:tx>
          <c:spPr>
            <a:ln w="12700">
              <a:solidFill>
                <a:schemeClr val="tx1"/>
              </a:solidFill>
              <a:prstDash val="dash"/>
            </a:ln>
          </c:spPr>
          <c:marker>
            <c:symbol val="square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cat>
            <c:numRef>
              <c:f>GGDEF!$B$95:$H$9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GGDEF!$B$97:$H$97</c:f>
              <c:numCache>
                <c:formatCode>General</c:formatCode>
                <c:ptCount val="7"/>
                <c:pt idx="0">
                  <c:v>1</c:v>
                </c:pt>
                <c:pt idx="1">
                  <c:v>1.13508064516129</c:v>
                </c:pt>
                <c:pt idx="2">
                  <c:v>0.87298387096774199</c:v>
                </c:pt>
                <c:pt idx="3">
                  <c:v>1.195564516129032</c:v>
                </c:pt>
                <c:pt idx="4">
                  <c:v>2.433467741935484</c:v>
                </c:pt>
                <c:pt idx="5">
                  <c:v>2.270161290322581</c:v>
                </c:pt>
                <c:pt idx="6">
                  <c:v>1.61491935483871</c:v>
                </c:pt>
              </c:numCache>
            </c:numRef>
          </c:val>
          <c:smooth val="1"/>
        </c:ser>
        <c:ser>
          <c:idx val="2"/>
          <c:order val="2"/>
          <c:tx>
            <c:strRef>
              <c:f>GGDEF!$A$98</c:f>
              <c:strCache>
                <c:ptCount val="1"/>
                <c:pt idx="0">
                  <c:v>EAL-GGDEF (Xoo2708)</c:v>
                </c:pt>
              </c:strCache>
            </c:strRef>
          </c:tx>
          <c:spPr>
            <a:ln w="12700">
              <a:solidFill>
                <a:schemeClr val="tx1"/>
              </a:solidFill>
              <a:prstDash val="lgDash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GGDEF!$B$95:$H$9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GGDEF!$B$98:$H$98</c:f>
              <c:numCache>
                <c:formatCode>General</c:formatCode>
                <c:ptCount val="7"/>
                <c:pt idx="0">
                  <c:v>1</c:v>
                </c:pt>
                <c:pt idx="1">
                  <c:v>1.4986195472114849</c:v>
                </c:pt>
                <c:pt idx="2">
                  <c:v>1.310877967973495</c:v>
                </c:pt>
                <c:pt idx="3">
                  <c:v>1.8227498619547211</c:v>
                </c:pt>
                <c:pt idx="4">
                  <c:v>2.0485919381557158</c:v>
                </c:pt>
                <c:pt idx="5">
                  <c:v>2.0342352291551631</c:v>
                </c:pt>
                <c:pt idx="6">
                  <c:v>1.4831584759801211</c:v>
                </c:pt>
              </c:numCache>
            </c:numRef>
          </c:val>
          <c:smooth val="1"/>
        </c:ser>
        <c:ser>
          <c:idx val="3"/>
          <c:order val="3"/>
          <c:tx>
            <c:strRef>
              <c:f>GGDEF!$A$99</c:f>
              <c:strCache>
                <c:ptCount val="1"/>
                <c:pt idx="0">
                  <c:v>EAL-GGDEF (Xoo2860)</c:v>
                </c:pt>
              </c:strCache>
            </c:strRef>
          </c:tx>
          <c:spPr>
            <a:ln w="12700">
              <a:solidFill>
                <a:schemeClr val="tx1"/>
              </a:solidFill>
              <a:prstDash val="lgDash"/>
            </a:ln>
          </c:spPr>
          <c:marker>
            <c:symbol val="circle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cat>
            <c:numRef>
              <c:f>GGDEF!$B$95:$H$9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GGDEF!$B$99:$H$99</c:f>
              <c:numCache>
                <c:formatCode>General</c:formatCode>
                <c:ptCount val="7"/>
                <c:pt idx="0">
                  <c:v>1</c:v>
                </c:pt>
                <c:pt idx="1">
                  <c:v>1.045465777118854</c:v>
                </c:pt>
                <c:pt idx="2">
                  <c:v>0.88954781319495901</c:v>
                </c:pt>
                <c:pt idx="3">
                  <c:v>0.90733876945885805</c:v>
                </c:pt>
                <c:pt idx="4">
                  <c:v>1.3989374845564619</c:v>
                </c:pt>
                <c:pt idx="5">
                  <c:v>1.0340993328391399</c:v>
                </c:pt>
                <c:pt idx="6">
                  <c:v>0.81826043983197405</c:v>
                </c:pt>
              </c:numCache>
            </c:numRef>
          </c:val>
          <c:smooth val="1"/>
        </c:ser>
        <c:ser>
          <c:idx val="4"/>
          <c:order val="4"/>
          <c:tx>
            <c:strRef>
              <c:f>GGDEF!$A$100</c:f>
              <c:strCache>
                <c:ptCount val="1"/>
                <c:pt idx="0">
                  <c:v>EAL-GGDEF (Xoo3246)</c:v>
                </c:pt>
              </c:strCache>
            </c:strRef>
          </c:tx>
          <c:spPr>
            <a:ln w="12700">
              <a:solidFill>
                <a:schemeClr val="tx1"/>
              </a:solidFill>
              <a:prstDash val="lgDashDot"/>
            </a:ln>
          </c:spPr>
          <c:marker>
            <c:symbol val="diamond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GGDEF!$B$95:$H$9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GGDEF!$B$100:$H$100</c:f>
              <c:numCache>
                <c:formatCode>General</c:formatCode>
                <c:ptCount val="7"/>
                <c:pt idx="0">
                  <c:v>1</c:v>
                </c:pt>
                <c:pt idx="1">
                  <c:v>0.73657612128869199</c:v>
                </c:pt>
                <c:pt idx="2">
                  <c:v>0.47946936197094098</c:v>
                </c:pt>
                <c:pt idx="3">
                  <c:v>0.60202147820593799</c:v>
                </c:pt>
                <c:pt idx="4">
                  <c:v>1.3594440934933669</c:v>
                </c:pt>
                <c:pt idx="5">
                  <c:v>1.229311433986102</c:v>
                </c:pt>
                <c:pt idx="6">
                  <c:v>0.80227416298167997</c:v>
                </c:pt>
              </c:numCache>
            </c:numRef>
          </c:val>
          <c:smooth val="1"/>
        </c:ser>
        <c:ser>
          <c:idx val="5"/>
          <c:order val="5"/>
          <c:tx>
            <c:strRef>
              <c:f>GGDEF!$J$118</c:f>
              <c:strCache>
                <c:ptCount val="1"/>
                <c:pt idx="0">
                  <c:v>EAL-GGDEF (Xoo2561) control</c:v>
                </c:pt>
              </c:strCache>
            </c:strRef>
          </c:tx>
          <c:spPr>
            <a:ln w="12700">
              <a:solidFill>
                <a:srgbClr val="FF0000"/>
              </a:solidFill>
            </a:ln>
          </c:spPr>
          <c:marker>
            <c:symbol val="square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cat>
            <c:numRef>
              <c:f>GGDEF!$B$95:$H$9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GGDEF!$K$118:$Q$118</c:f>
              <c:numCache>
                <c:formatCode>General</c:formatCode>
                <c:ptCount val="7"/>
                <c:pt idx="0">
                  <c:v>1</c:v>
                </c:pt>
                <c:pt idx="1">
                  <c:v>0.75441231693578703</c:v>
                </c:pt>
                <c:pt idx="2">
                  <c:v>0.78482914006759297</c:v>
                </c:pt>
                <c:pt idx="3">
                  <c:v>0.975591438227563</c:v>
                </c:pt>
                <c:pt idx="4">
                  <c:v>0.97934660157716902</c:v>
                </c:pt>
                <c:pt idx="5">
                  <c:v>0.975591438227563</c:v>
                </c:pt>
                <c:pt idx="6">
                  <c:v>1.025385764061723</c:v>
                </c:pt>
              </c:numCache>
            </c:numRef>
          </c:val>
          <c:smooth val="0"/>
        </c:ser>
        <c:ser>
          <c:idx val="6"/>
          <c:order val="6"/>
          <c:tx>
            <c:strRef>
              <c:f>GGDEF!$J$119</c:f>
              <c:strCache>
                <c:ptCount val="1"/>
                <c:pt idx="0">
                  <c:v>EAL-GGDEF (Xoo2616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dash"/>
            </a:ln>
          </c:spPr>
          <c:marker>
            <c:symbol val="square"/>
            <c:size val="5"/>
            <c:spPr>
              <a:noFill/>
              <a:ln>
                <a:solidFill>
                  <a:srgbClr val="FF0000"/>
                </a:solidFill>
              </a:ln>
            </c:spPr>
          </c:marker>
          <c:cat>
            <c:numRef>
              <c:f>GGDEF!$B$95:$H$9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GGDEF!$K$119:$Q$119</c:f>
              <c:numCache>
                <c:formatCode>General</c:formatCode>
                <c:ptCount val="7"/>
                <c:pt idx="0">
                  <c:v>1</c:v>
                </c:pt>
                <c:pt idx="1">
                  <c:v>0.65728476821191995</c:v>
                </c:pt>
                <c:pt idx="2">
                  <c:v>0.79139072847682101</c:v>
                </c:pt>
                <c:pt idx="3">
                  <c:v>0.81125827814569496</c:v>
                </c:pt>
                <c:pt idx="4">
                  <c:v>1.125827814569536</c:v>
                </c:pt>
                <c:pt idx="5">
                  <c:v>0.95529801324503305</c:v>
                </c:pt>
                <c:pt idx="6">
                  <c:v>0.95465994962216605</c:v>
                </c:pt>
              </c:numCache>
            </c:numRef>
          </c:val>
          <c:smooth val="0"/>
        </c:ser>
        <c:ser>
          <c:idx val="7"/>
          <c:order val="7"/>
          <c:tx>
            <c:strRef>
              <c:f>GGDEF!$J$120</c:f>
              <c:strCache>
                <c:ptCount val="1"/>
                <c:pt idx="0">
                  <c:v>EAL-GGDEF (Xoo2708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lgDash"/>
            </a:ln>
          </c:spPr>
          <c:marker>
            <c:symbol val="circle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cat>
            <c:numRef>
              <c:f>GGDEF!$B$95:$H$9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GGDEF!$K$120:$Q$120</c:f>
              <c:numCache>
                <c:formatCode>General</c:formatCode>
                <c:ptCount val="7"/>
                <c:pt idx="0">
                  <c:v>1</c:v>
                </c:pt>
                <c:pt idx="1">
                  <c:v>1.0409972299168979</c:v>
                </c:pt>
                <c:pt idx="2">
                  <c:v>1.0360110803324101</c:v>
                </c:pt>
                <c:pt idx="3">
                  <c:v>1.0991689750692519</c:v>
                </c:pt>
                <c:pt idx="4">
                  <c:v>1.151246537396122</c:v>
                </c:pt>
                <c:pt idx="5">
                  <c:v>1.01218836565097</c:v>
                </c:pt>
                <c:pt idx="6">
                  <c:v>0.79670037253858506</c:v>
                </c:pt>
              </c:numCache>
            </c:numRef>
          </c:val>
          <c:smooth val="0"/>
        </c:ser>
        <c:ser>
          <c:idx val="8"/>
          <c:order val="8"/>
          <c:tx>
            <c:strRef>
              <c:f>GGDEF!$J$121</c:f>
              <c:strCache>
                <c:ptCount val="1"/>
                <c:pt idx="0">
                  <c:v>EAL-GGDEF (Xoo2860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lgDash"/>
            </a:ln>
          </c:spPr>
          <c:marker>
            <c:symbol val="circle"/>
            <c:size val="5"/>
            <c:spPr>
              <a:noFill/>
              <a:ln>
                <a:solidFill>
                  <a:srgbClr val="FF0000"/>
                </a:solidFill>
              </a:ln>
            </c:spPr>
          </c:marker>
          <c:cat>
            <c:numRef>
              <c:f>GGDEF!$B$95:$H$9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GGDEF!$K$121:$Q$121</c:f>
              <c:numCache>
                <c:formatCode>General</c:formatCode>
                <c:ptCount val="7"/>
                <c:pt idx="0">
                  <c:v>1</c:v>
                </c:pt>
                <c:pt idx="1">
                  <c:v>1.3980690679539549</c:v>
                </c:pt>
                <c:pt idx="2">
                  <c:v>1.1779923257828939</c:v>
                </c:pt>
                <c:pt idx="3">
                  <c:v>1.3134051243965841</c:v>
                </c:pt>
                <c:pt idx="4">
                  <c:v>1.067335066221067</c:v>
                </c:pt>
                <c:pt idx="5">
                  <c:v>0.94702314642901397</c:v>
                </c:pt>
                <c:pt idx="6">
                  <c:v>0.637361664453298</c:v>
                </c:pt>
              </c:numCache>
            </c:numRef>
          </c:val>
          <c:smooth val="0"/>
        </c:ser>
        <c:ser>
          <c:idx val="9"/>
          <c:order val="9"/>
          <c:tx>
            <c:strRef>
              <c:f>GGDEF!$J$122</c:f>
              <c:strCache>
                <c:ptCount val="1"/>
                <c:pt idx="0">
                  <c:v>EAL-GGDEF (Xoo3246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lgDashDot"/>
            </a:ln>
          </c:spPr>
          <c:marker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cat>
            <c:numRef>
              <c:f>GGDEF!$B$95:$H$95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GGDEF!$K$122:$Q$122</c:f>
              <c:numCache>
                <c:formatCode>General</c:formatCode>
                <c:ptCount val="7"/>
                <c:pt idx="0">
                  <c:v>1</c:v>
                </c:pt>
                <c:pt idx="1">
                  <c:v>1.127487562189055</c:v>
                </c:pt>
                <c:pt idx="2">
                  <c:v>0.933457711442786</c:v>
                </c:pt>
                <c:pt idx="3">
                  <c:v>1.2325870646766171</c:v>
                </c:pt>
                <c:pt idx="4">
                  <c:v>1.458955223880597</c:v>
                </c:pt>
                <c:pt idx="5">
                  <c:v>1.2543532338308461</c:v>
                </c:pt>
                <c:pt idx="6">
                  <c:v>0.8279095421952570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3677056"/>
        <c:axId val="73683328"/>
      </c:lineChart>
      <c:catAx>
        <c:axId val="736770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  <c:crossAx val="73683328"/>
        <c:crosses val="autoZero"/>
        <c:auto val="1"/>
        <c:lblAlgn val="ctr"/>
        <c:lblOffset val="100"/>
        <c:noMultiLvlLbl val="0"/>
      </c:catAx>
      <c:valAx>
        <c:axId val="73683328"/>
        <c:scaling>
          <c:orientation val="minMax"/>
          <c:max val="4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  <c:crossAx val="73677056"/>
        <c:crosses val="autoZero"/>
        <c:crossBetween val="between"/>
        <c:majorUnit val="1"/>
      </c:valAx>
    </c:plotArea>
    <c:legend>
      <c:legendPos val="r"/>
      <c:layout>
        <c:manualLayout>
          <c:xMode val="edge"/>
          <c:yMode val="edge"/>
          <c:x val="0.36667793413025002"/>
          <c:y val="0.35193689092950098"/>
          <c:w val="0.28248560443638598"/>
          <c:h val="0.64806310907049902"/>
        </c:manualLayout>
      </c:layout>
      <c:overlay val="0"/>
      <c:txPr>
        <a:bodyPr/>
        <a:lstStyle/>
        <a:p>
          <a:pPr>
            <a:defRPr sz="800" i="1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5.0192933303235897E-2"/>
          <c:y val="0.34748861778752299"/>
          <c:w val="0.32208562847855599"/>
          <c:h val="0.52738824828492303"/>
        </c:manualLayout>
      </c:layout>
      <c:lineChart>
        <c:grouping val="standard"/>
        <c:varyColors val="0"/>
        <c:ser>
          <c:idx val="0"/>
          <c:order val="0"/>
          <c:tx>
            <c:strRef>
              <c:f>GGDEF!$A$90</c:f>
              <c:strCache>
                <c:ptCount val="1"/>
                <c:pt idx="0">
                  <c:v>HD-GYP (Xoo2798)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GGDEF!$B$89:$H$89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GGDEF!$B$90:$H$90</c:f>
              <c:numCache>
                <c:formatCode>General</c:formatCode>
                <c:ptCount val="7"/>
                <c:pt idx="0">
                  <c:v>1</c:v>
                </c:pt>
                <c:pt idx="1">
                  <c:v>1.329091551785083</c:v>
                </c:pt>
                <c:pt idx="2">
                  <c:v>0.805761753269707</c:v>
                </c:pt>
                <c:pt idx="3">
                  <c:v>0.66507599858607303</c:v>
                </c:pt>
                <c:pt idx="4">
                  <c:v>0.40402969247083798</c:v>
                </c:pt>
                <c:pt idx="5">
                  <c:v>0.45546129374337202</c:v>
                </c:pt>
                <c:pt idx="6">
                  <c:v>0.36055143160127201</c:v>
                </c:pt>
              </c:numCache>
            </c:numRef>
          </c:val>
          <c:smooth val="1"/>
        </c:ser>
        <c:ser>
          <c:idx val="1"/>
          <c:order val="1"/>
          <c:tx>
            <c:strRef>
              <c:f>GGDEF!$A$91</c:f>
              <c:strCache>
                <c:ptCount val="1"/>
                <c:pt idx="0">
                  <c:v>HD-GYP (Xoo2871)</c:v>
                </c:pt>
              </c:strCache>
            </c:strRef>
          </c:tx>
          <c:spPr>
            <a:ln w="12700">
              <a:solidFill>
                <a:schemeClr val="tx1"/>
              </a:solidFill>
              <a:prstDash val="dash"/>
            </a:ln>
          </c:spPr>
          <c:marker>
            <c:symbol val="square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cat>
            <c:numRef>
              <c:f>GGDEF!$B$89:$H$89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GGDEF!$B$91:$H$91</c:f>
              <c:numCache>
                <c:formatCode>General</c:formatCode>
                <c:ptCount val="7"/>
                <c:pt idx="0">
                  <c:v>1</c:v>
                </c:pt>
                <c:pt idx="1">
                  <c:v>1.056070664398969</c:v>
                </c:pt>
                <c:pt idx="2">
                  <c:v>1.0084764360564</c:v>
                </c:pt>
                <c:pt idx="3">
                  <c:v>1.2367915729412411</c:v>
                </c:pt>
                <c:pt idx="4">
                  <c:v>1.400559609370714</c:v>
                </c:pt>
                <c:pt idx="5">
                  <c:v>1.2343227080704451</c:v>
                </c:pt>
                <c:pt idx="6">
                  <c:v>1.1331541120316011</c:v>
                </c:pt>
              </c:numCache>
            </c:numRef>
          </c:val>
          <c:smooth val="1"/>
        </c:ser>
        <c:ser>
          <c:idx val="2"/>
          <c:order val="2"/>
          <c:tx>
            <c:strRef>
              <c:f>GGDEF!$A$92</c:f>
              <c:strCache>
                <c:ptCount val="1"/>
                <c:pt idx="0">
                  <c:v>HD-GYP (Xoo4220)</c:v>
                </c:pt>
              </c:strCache>
            </c:strRef>
          </c:tx>
          <c:spPr>
            <a:ln w="12700">
              <a:solidFill>
                <a:schemeClr val="tx1"/>
              </a:solidFill>
              <a:prstDash val="lgDash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cat>
            <c:numRef>
              <c:f>GGDEF!$B$89:$H$89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GGDEF!$B$92:$H$92</c:f>
              <c:numCache>
                <c:formatCode>General</c:formatCode>
                <c:ptCount val="7"/>
                <c:pt idx="0">
                  <c:v>1</c:v>
                </c:pt>
                <c:pt idx="1">
                  <c:v>0.73316122975827303</c:v>
                </c:pt>
                <c:pt idx="2">
                  <c:v>0.62098099037784604</c:v>
                </c:pt>
                <c:pt idx="3">
                  <c:v>0.992959399202065</c:v>
                </c:pt>
                <c:pt idx="4">
                  <c:v>2.6491433935695841</c:v>
                </c:pt>
                <c:pt idx="5">
                  <c:v>2.5233513259798168</c:v>
                </c:pt>
                <c:pt idx="6">
                  <c:v>2.1926777751701478</c:v>
                </c:pt>
              </c:numCache>
            </c:numRef>
          </c:val>
          <c:smooth val="1"/>
        </c:ser>
        <c:ser>
          <c:idx val="3"/>
          <c:order val="3"/>
          <c:tx>
            <c:strRef>
              <c:f>GGDEF!$A$163</c:f>
              <c:strCache>
                <c:ptCount val="1"/>
                <c:pt idx="0">
                  <c:v>HD-GYP (Xoo2798) control</c:v>
                </c:pt>
              </c:strCache>
            </c:strRef>
          </c:tx>
          <c:spPr>
            <a:ln w="12700">
              <a:solidFill>
                <a:srgbClr val="FF0000"/>
              </a:solidFill>
            </a:ln>
          </c:spPr>
          <c:marker>
            <c:symbol val="square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cat>
            <c:numRef>
              <c:f>GGDEF!$B$89:$H$89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GGDEF!$B$163:$H$163</c:f>
              <c:numCache>
                <c:formatCode>General</c:formatCode>
                <c:ptCount val="7"/>
                <c:pt idx="0">
                  <c:v>1</c:v>
                </c:pt>
                <c:pt idx="1">
                  <c:v>1.1280842369951281</c:v>
                </c:pt>
                <c:pt idx="2">
                  <c:v>0.97045418827596996</c:v>
                </c:pt>
                <c:pt idx="3">
                  <c:v>0.97941222693697905</c:v>
                </c:pt>
                <c:pt idx="4">
                  <c:v>1.08989470375609</c:v>
                </c:pt>
                <c:pt idx="5">
                  <c:v>0.91984912776992001</c:v>
                </c:pt>
                <c:pt idx="6">
                  <c:v>0.93383624076693394</c:v>
                </c:pt>
              </c:numCache>
            </c:numRef>
          </c:val>
          <c:smooth val="1"/>
        </c:ser>
        <c:ser>
          <c:idx val="4"/>
          <c:order val="4"/>
          <c:tx>
            <c:strRef>
              <c:f>GGDEF!$A$164</c:f>
              <c:strCache>
                <c:ptCount val="1"/>
                <c:pt idx="0">
                  <c:v>HD-GYP (Xoo2871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dash"/>
            </a:ln>
          </c:spPr>
          <c:marker>
            <c:symbol val="square"/>
            <c:size val="5"/>
            <c:spPr>
              <a:noFill/>
              <a:ln>
                <a:solidFill>
                  <a:srgbClr val="FF0000"/>
                </a:solidFill>
              </a:ln>
            </c:spPr>
          </c:marker>
          <c:cat>
            <c:numRef>
              <c:f>GGDEF!$B$89:$H$89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GGDEF!$B$164:$H$164</c:f>
              <c:numCache>
                <c:formatCode>General</c:formatCode>
                <c:ptCount val="7"/>
                <c:pt idx="0">
                  <c:v>1</c:v>
                </c:pt>
                <c:pt idx="1">
                  <c:v>0.98920579448734602</c:v>
                </c:pt>
                <c:pt idx="2">
                  <c:v>0.93791218082408001</c:v>
                </c:pt>
                <c:pt idx="3">
                  <c:v>1.0625951186517111</c:v>
                </c:pt>
                <c:pt idx="4">
                  <c:v>1.096048700749676</c:v>
                </c:pt>
                <c:pt idx="5">
                  <c:v>0.96716645059466799</c:v>
                </c:pt>
                <c:pt idx="6">
                  <c:v>0.90975705991770495</c:v>
                </c:pt>
              </c:numCache>
            </c:numRef>
          </c:val>
          <c:smooth val="1"/>
        </c:ser>
        <c:ser>
          <c:idx val="5"/>
          <c:order val="5"/>
          <c:tx>
            <c:strRef>
              <c:f>GGDEF!$A$165</c:f>
              <c:strCache>
                <c:ptCount val="1"/>
                <c:pt idx="0">
                  <c:v>HD-GYP (Xoo4220) control</c:v>
                </c:pt>
              </c:strCache>
            </c:strRef>
          </c:tx>
          <c:spPr>
            <a:ln w="12700">
              <a:solidFill>
                <a:srgbClr val="FF0000"/>
              </a:solidFill>
              <a:prstDash val="lgDash"/>
            </a:ln>
          </c:spPr>
          <c:marker>
            <c:symbol val="circle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cat>
            <c:numRef>
              <c:f>GGDEF!$B$89:$H$89</c:f>
              <c:numCache>
                <c:formatCode>General</c:formatCode>
                <c:ptCount val="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30</c:v>
                </c:pt>
                <c:pt idx="5">
                  <c:v>45</c:v>
                </c:pt>
                <c:pt idx="6">
                  <c:v>60</c:v>
                </c:pt>
              </c:numCache>
            </c:numRef>
          </c:cat>
          <c:val>
            <c:numRef>
              <c:f>GGDEF!$B$165:$H$165</c:f>
              <c:numCache>
                <c:formatCode>General</c:formatCode>
                <c:ptCount val="7"/>
                <c:pt idx="0">
                  <c:v>1</c:v>
                </c:pt>
                <c:pt idx="1">
                  <c:v>0.93702290076335903</c:v>
                </c:pt>
                <c:pt idx="2">
                  <c:v>0.92620865139949105</c:v>
                </c:pt>
                <c:pt idx="3">
                  <c:v>0.993956743002544</c:v>
                </c:pt>
                <c:pt idx="4">
                  <c:v>0.97487277353689605</c:v>
                </c:pt>
                <c:pt idx="5">
                  <c:v>1.147900763358779</c:v>
                </c:pt>
                <c:pt idx="6">
                  <c:v>0.99522900763358801</c:v>
                </c:pt>
              </c:numCache>
            </c:numRef>
          </c: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73710976"/>
        <c:axId val="73725440"/>
      </c:lineChart>
      <c:catAx>
        <c:axId val="737109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  <c:crossAx val="73725440"/>
        <c:crosses val="autoZero"/>
        <c:auto val="1"/>
        <c:lblAlgn val="ctr"/>
        <c:lblOffset val="100"/>
        <c:noMultiLvlLbl val="0"/>
      </c:catAx>
      <c:valAx>
        <c:axId val="737254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defRPr>
            </a:pPr>
            <a:endParaRPr lang="en-US"/>
          </a:p>
        </c:txPr>
        <c:crossAx val="73710976"/>
        <c:crosses val="autoZero"/>
        <c:crossBetween val="between"/>
        <c:majorUnit val="1"/>
      </c:valAx>
    </c:plotArea>
    <c:legend>
      <c:legendPos val="r"/>
      <c:layout>
        <c:manualLayout>
          <c:xMode val="edge"/>
          <c:yMode val="edge"/>
          <c:x val="0.37089472137504398"/>
          <c:y val="0.399451410169882"/>
          <c:w val="0.24768170920077001"/>
          <c:h val="0.47579499516262802"/>
        </c:manualLayout>
      </c:layout>
      <c:overlay val="0"/>
      <c:txPr>
        <a:bodyPr/>
        <a:lstStyle/>
        <a:p>
          <a:pPr>
            <a:defRPr sz="800" i="1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16717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0609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081316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61971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45847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46490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31652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567334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81350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34146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33609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A19398-829A-4FE9-B8F6-065630817ED9}" type="datetimeFigureOut">
              <a:rPr lang="ko-KR" altLang="en-US" smtClean="0"/>
              <a:t>2016-04-2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3C7092-E695-4DD5-8F71-C4941DEAD8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26264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72336" y="1044110"/>
            <a:ext cx="6990733" cy="2885776"/>
            <a:chOff x="749619" y="2132856"/>
            <a:chExt cx="6990733" cy="2885776"/>
          </a:xfrm>
        </p:grpSpPr>
        <p:graphicFrame>
          <p:nvGraphicFramePr>
            <p:cNvPr id="5" name="차트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25057647"/>
                </p:ext>
              </p:extLst>
            </p:nvPr>
          </p:nvGraphicFramePr>
          <p:xfrm>
            <a:off x="971600" y="2132856"/>
            <a:ext cx="6768752" cy="272772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" name="TextBox 5"/>
            <p:cNvSpPr txBox="1"/>
            <p:nvPr/>
          </p:nvSpPr>
          <p:spPr>
            <a:xfrm rot="16200000">
              <a:off x="383332" y="3596515"/>
              <a:ext cx="99418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Fold Change</a:t>
              </a:r>
              <a:endParaRPr lang="ko-KR" altLang="en-US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145789" y="4757022"/>
              <a:ext cx="4988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Time</a:t>
              </a:r>
              <a:endParaRPr lang="ko-KR" altLang="en-US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grpSp>
        <p:nvGrpSpPr>
          <p:cNvPr id="8" name="그룹 7"/>
          <p:cNvGrpSpPr/>
          <p:nvPr/>
        </p:nvGrpSpPr>
        <p:grpSpPr>
          <a:xfrm>
            <a:off x="4750461" y="1036824"/>
            <a:ext cx="6895907" cy="2905521"/>
            <a:chOff x="772437" y="2132856"/>
            <a:chExt cx="6895907" cy="2905521"/>
          </a:xfrm>
        </p:grpSpPr>
        <p:graphicFrame>
          <p:nvGraphicFramePr>
            <p:cNvPr id="9" name="차트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27580090"/>
                </p:ext>
              </p:extLst>
            </p:nvPr>
          </p:nvGraphicFramePr>
          <p:xfrm>
            <a:off x="971600" y="2132856"/>
            <a:ext cx="6696744" cy="272772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0" name="TextBox 9"/>
            <p:cNvSpPr txBox="1"/>
            <p:nvPr/>
          </p:nvSpPr>
          <p:spPr>
            <a:xfrm rot="16200000">
              <a:off x="406150" y="3515906"/>
              <a:ext cx="99418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Fold Change</a:t>
              </a:r>
              <a:endParaRPr lang="ko-KR" altLang="en-US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154415" y="4776767"/>
              <a:ext cx="4988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Time</a:t>
              </a:r>
              <a:endParaRPr lang="ko-KR" altLang="en-US" sz="11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2684" y="82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Figure S5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79512" y="1464528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(A)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790845" y="1473820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(B)</a:t>
            </a:r>
            <a:endParaRPr lang="ko-KR" altLang="en-US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41505132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11</TotalTime>
  <Words>14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rdausr</dc:creator>
  <cp:lastModifiedBy>Banua, Arvin</cp:lastModifiedBy>
  <cp:revision>27</cp:revision>
  <dcterms:created xsi:type="dcterms:W3CDTF">2016-01-26T07:31:38Z</dcterms:created>
  <dcterms:modified xsi:type="dcterms:W3CDTF">2016-04-28T09:52:56Z</dcterms:modified>
</cp:coreProperties>
</file>